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2" autoAdjust="0"/>
    <p:restoredTop sz="94660"/>
  </p:normalViewPr>
  <p:slideViewPr>
    <p:cSldViewPr snapToGrid="0">
      <p:cViewPr varScale="1">
        <p:scale>
          <a:sx n="73" d="100"/>
          <a:sy n="73" d="100"/>
        </p:scale>
        <p:origin x="40" y="5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30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19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432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348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969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734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358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464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178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614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86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F55C8-3DAD-40B9-8002-6FA13B907FFD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587F2-ED2B-4B47-A635-AEB1870C4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315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ounded Rectangle 12"/>
          <p:cNvSpPr/>
          <p:nvPr/>
        </p:nvSpPr>
        <p:spPr>
          <a:xfrm>
            <a:off x="4257470" y="2564106"/>
            <a:ext cx="3705220" cy="2071516"/>
          </a:xfrm>
          <a:prstGeom prst="roundRect">
            <a:avLst>
              <a:gd name="adj" fmla="val 3050"/>
            </a:avLst>
          </a:prstGeom>
          <a:gradFill flip="none" rotWithShape="1">
            <a:gsLst>
              <a:gs pos="0">
                <a:srgbClr val="FF0000">
                  <a:alpha val="51000"/>
                </a:srgbClr>
              </a:gs>
              <a:gs pos="49000">
                <a:srgbClr val="00B050">
                  <a:lumMod val="100000"/>
                  <a:alpha val="52000"/>
                </a:srgbClr>
              </a:gs>
              <a:gs pos="100000">
                <a:schemeClr val="accent1">
                  <a:alpha val="50000"/>
                  <a:lumMod val="98000"/>
                  <a:lumOff val="2000"/>
                </a:scheme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3233390"/>
              </p:ext>
            </p:extLst>
          </p:nvPr>
        </p:nvGraphicFramePr>
        <p:xfrm>
          <a:off x="3158246" y="1030877"/>
          <a:ext cx="4804444" cy="1391499"/>
        </p:xfrm>
        <a:graphic>
          <a:graphicData uri="http://schemas.openxmlformats.org/drawingml/2006/table">
            <a:tbl>
              <a:tblPr bandRow="1">
                <a:tableStyleId>{073A0DAA-6AF3-43AB-8588-CEC1D06C72B9}</a:tableStyleId>
              </a:tblPr>
              <a:tblGrid>
                <a:gridCol w="108693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0331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0378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6677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0425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3937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93887">
                <a:tc>
                  <a:txBody>
                    <a:bodyPr/>
                    <a:lstStyle/>
                    <a:p>
                      <a:pPr algn="ctr"/>
                      <a:r>
                        <a:rPr lang="en-US" sz="1400" b="0" dirty="0"/>
                        <a:t># of component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i="1" baseline="-25000" dirty="0"/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baseline="-25000" dirty="0"/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baseline="-25000" dirty="0"/>
                        <a:t>(transitio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baseline="-25000" dirty="0"/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baseline="-25000" dirty="0"/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baseline="-25000" dirty="0"/>
                        <a:t>(transitio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baseline="-25000" dirty="0"/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59757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Diffusion times</a:t>
                      </a:r>
                      <a:endParaRPr lang="en-US" sz="1400" b="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400" i="1" dirty="0">
                          <a:solidFill>
                            <a:schemeClr val="accent1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chemeClr val="accent1"/>
                          </a:solidFill>
                        </a:rPr>
                        <a:t>D1</a:t>
                      </a:r>
                      <a:endParaRPr lang="en-US" sz="1400" b="0" i="1" baseline="-25000" dirty="0">
                        <a:solidFill>
                          <a:schemeClr val="accent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400" i="1" dirty="0">
                          <a:solidFill>
                            <a:schemeClr val="accent1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chemeClr val="accent1"/>
                          </a:solidFill>
                        </a:rPr>
                        <a:t>D1</a:t>
                      </a:r>
                      <a:r>
                        <a:rPr lang="en-US" sz="1400" i="1" dirty="0">
                          <a:solidFill>
                            <a:schemeClr val="accent1"/>
                          </a:solidFill>
                        </a:rPr>
                        <a:t> </a:t>
                      </a:r>
                      <a:r>
                        <a:rPr lang="en-US" sz="1400" i="1" dirty="0"/>
                        <a:t>&amp; </a:t>
                      </a:r>
                      <a:r>
                        <a:rPr lang="el-GR" sz="1400" i="1" dirty="0">
                          <a:solidFill>
                            <a:srgbClr val="00B050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rgbClr val="00B050"/>
                          </a:solidFill>
                        </a:rPr>
                        <a:t>D2</a:t>
                      </a:r>
                      <a:endParaRPr lang="en-US" sz="1400" b="0" i="1" baseline="-25000" dirty="0">
                        <a:solidFill>
                          <a:srgbClr val="00B05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400" i="1" dirty="0">
                          <a:solidFill>
                            <a:srgbClr val="00B050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rgbClr val="00B050"/>
                          </a:solidFill>
                        </a:rPr>
                        <a:t>D2</a:t>
                      </a:r>
                      <a:endParaRPr lang="en-US" sz="1400" b="0" i="1" baseline="-25000" dirty="0">
                        <a:solidFill>
                          <a:srgbClr val="00B05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400" i="1" dirty="0">
                          <a:solidFill>
                            <a:srgbClr val="00B050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rgbClr val="00B050"/>
                          </a:solidFill>
                        </a:rPr>
                        <a:t>D2 </a:t>
                      </a:r>
                      <a:r>
                        <a:rPr lang="en-US" sz="1400" i="1" dirty="0"/>
                        <a:t>&amp; </a:t>
                      </a:r>
                      <a:r>
                        <a:rPr lang="el-GR" sz="1400" i="1" dirty="0">
                          <a:solidFill>
                            <a:srgbClr val="FF0000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rgbClr val="FF0000"/>
                          </a:solidFill>
                        </a:rPr>
                        <a:t>D3</a:t>
                      </a:r>
                      <a:endParaRPr lang="en-US" sz="1400" b="0" i="1" baseline="-25000" dirty="0">
                        <a:solidFill>
                          <a:srgbClr val="FF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400" i="1" dirty="0">
                          <a:solidFill>
                            <a:srgbClr val="FF0000"/>
                          </a:solidFill>
                        </a:rPr>
                        <a:t>τ</a:t>
                      </a:r>
                      <a:r>
                        <a:rPr lang="en-US" sz="1400" i="1" baseline="-25000" dirty="0">
                          <a:solidFill>
                            <a:srgbClr val="FF0000"/>
                          </a:solidFill>
                        </a:rPr>
                        <a:t>D3</a:t>
                      </a:r>
                      <a:endParaRPr lang="en-US" sz="1400" b="0" i="1" baseline="-25000" dirty="0">
                        <a:solidFill>
                          <a:srgbClr val="FF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5517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mplitud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i="1" dirty="0">
                          <a:solidFill>
                            <a:schemeClr val="accent1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chemeClr val="accent1"/>
                          </a:solidFill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i="1" dirty="0">
                          <a:solidFill>
                            <a:schemeClr val="accent1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chemeClr val="accent1"/>
                          </a:solidFill>
                        </a:rPr>
                        <a:t>1</a:t>
                      </a:r>
                      <a:r>
                        <a:rPr lang="en-US" sz="1400" i="1" baseline="0" dirty="0"/>
                        <a:t> &amp;</a:t>
                      </a:r>
                      <a:r>
                        <a:rPr lang="en-US" sz="1400" i="1" dirty="0"/>
                        <a:t> </a:t>
                      </a:r>
                      <a:r>
                        <a:rPr lang="en-US" sz="1400" i="1" dirty="0">
                          <a:solidFill>
                            <a:srgbClr val="00B050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rgbClr val="00B050"/>
                          </a:solidFill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i="1" dirty="0">
                          <a:solidFill>
                            <a:srgbClr val="00B050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rgbClr val="00B050"/>
                          </a:solidFill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i="1" dirty="0">
                          <a:solidFill>
                            <a:srgbClr val="00B050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rgbClr val="00B050"/>
                          </a:solidFill>
                        </a:rPr>
                        <a:t>2</a:t>
                      </a:r>
                      <a:r>
                        <a:rPr lang="en-US" sz="1400" i="1" baseline="0" dirty="0"/>
                        <a:t> &amp;</a:t>
                      </a:r>
                      <a:r>
                        <a:rPr lang="en-US" sz="1400" i="1" dirty="0"/>
                        <a:t> </a:t>
                      </a:r>
                      <a:r>
                        <a:rPr lang="en-US" sz="1400" i="1" dirty="0">
                          <a:solidFill>
                            <a:srgbClr val="FF0000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rgbClr val="FF0000"/>
                          </a:solidFill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i="1" dirty="0">
                          <a:solidFill>
                            <a:srgbClr val="FF0000"/>
                          </a:solidFill>
                        </a:rPr>
                        <a:t>a</a:t>
                      </a:r>
                      <a:r>
                        <a:rPr lang="en-US" sz="1400" i="1" baseline="-25000" dirty="0">
                          <a:solidFill>
                            <a:srgbClr val="FF0000"/>
                          </a:solidFill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9" name="Freeform 8"/>
          <p:cNvSpPr/>
          <p:nvPr/>
        </p:nvSpPr>
        <p:spPr>
          <a:xfrm>
            <a:off x="4228286" y="2628283"/>
            <a:ext cx="1819072" cy="1981310"/>
          </a:xfrm>
          <a:custGeom>
            <a:avLst/>
            <a:gdLst>
              <a:gd name="connsiteX0" fmla="*/ 0 w 1819072"/>
              <a:gd name="connsiteY0" fmla="*/ 0 h 2334638"/>
              <a:gd name="connsiteX1" fmla="*/ 1060315 w 1819072"/>
              <a:gd name="connsiteY1" fmla="*/ 1050587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819072" h="2334638">
                <a:moveTo>
                  <a:pt x="0" y="0"/>
                </a:moveTo>
                <a:cubicBezTo>
                  <a:pt x="670398" y="19455"/>
                  <a:pt x="971144" y="632297"/>
                  <a:pt x="1050587" y="1060314"/>
                </a:cubicBezTo>
                <a:cubicBezTo>
                  <a:pt x="1130030" y="1488331"/>
                  <a:pt x="1260543" y="2334637"/>
                  <a:pt x="1819072" y="2334638"/>
                </a:cubicBezTo>
              </a:path>
            </a:pathLst>
          </a:cu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Freeform 9"/>
          <p:cNvSpPr/>
          <p:nvPr/>
        </p:nvSpPr>
        <p:spPr>
          <a:xfrm flipV="1">
            <a:off x="6076541" y="2628283"/>
            <a:ext cx="1867711" cy="1981310"/>
          </a:xfrm>
          <a:custGeom>
            <a:avLst/>
            <a:gdLst>
              <a:gd name="connsiteX0" fmla="*/ 0 w 1819072"/>
              <a:gd name="connsiteY0" fmla="*/ 0 h 2334638"/>
              <a:gd name="connsiteX1" fmla="*/ 1060315 w 1819072"/>
              <a:gd name="connsiteY1" fmla="*/ 1050587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109 h 2334747"/>
              <a:gd name="connsiteX1" fmla="*/ 1050587 w 1819072"/>
              <a:gd name="connsiteY1" fmla="*/ 1060423 h 2334747"/>
              <a:gd name="connsiteX2" fmla="*/ 1819072 w 1819072"/>
              <a:gd name="connsiteY2" fmla="*/ 2334747 h 2334747"/>
              <a:gd name="connsiteX0" fmla="*/ 0 w 1819072"/>
              <a:gd name="connsiteY0" fmla="*/ 109 h 2334747"/>
              <a:gd name="connsiteX1" fmla="*/ 1050587 w 1819072"/>
              <a:gd name="connsiteY1" fmla="*/ 1060423 h 2334747"/>
              <a:gd name="connsiteX2" fmla="*/ 1819072 w 1819072"/>
              <a:gd name="connsiteY2" fmla="*/ 2334747 h 2334747"/>
              <a:gd name="connsiteX0" fmla="*/ 0 w 1819072"/>
              <a:gd name="connsiteY0" fmla="*/ 0 h 2334638"/>
              <a:gd name="connsiteX1" fmla="*/ 1050587 w 1819072"/>
              <a:gd name="connsiteY1" fmla="*/ 1060314 h 2334638"/>
              <a:gd name="connsiteX2" fmla="*/ 1819072 w 1819072"/>
              <a:gd name="connsiteY2" fmla="*/ 2334638 h 2334638"/>
              <a:gd name="connsiteX0" fmla="*/ 0 w 1819072"/>
              <a:gd name="connsiteY0" fmla="*/ 0 h 2334638"/>
              <a:gd name="connsiteX1" fmla="*/ 897294 w 1819072"/>
              <a:gd name="connsiteY1" fmla="*/ 1118680 h 2334638"/>
              <a:gd name="connsiteX2" fmla="*/ 1819072 w 1819072"/>
              <a:gd name="connsiteY2" fmla="*/ 2334638 h 23346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819072" h="2334638">
                <a:moveTo>
                  <a:pt x="0" y="0"/>
                </a:moveTo>
                <a:cubicBezTo>
                  <a:pt x="476228" y="19455"/>
                  <a:pt x="817851" y="690663"/>
                  <a:pt x="897294" y="1118680"/>
                </a:cubicBezTo>
                <a:cubicBezTo>
                  <a:pt x="976737" y="1546697"/>
                  <a:pt x="1086811" y="2334637"/>
                  <a:pt x="1819072" y="2334638"/>
                </a:cubicBezTo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reeform 10"/>
          <p:cNvSpPr/>
          <p:nvPr/>
        </p:nvSpPr>
        <p:spPr>
          <a:xfrm>
            <a:off x="4257470" y="2628284"/>
            <a:ext cx="3686783" cy="1981309"/>
          </a:xfrm>
          <a:custGeom>
            <a:avLst/>
            <a:gdLst>
              <a:gd name="connsiteX0" fmla="*/ 0 w 3686783"/>
              <a:gd name="connsiteY0" fmla="*/ 2597291 h 2597291"/>
              <a:gd name="connsiteX1" fmla="*/ 1780161 w 3686783"/>
              <a:gd name="connsiteY1" fmla="*/ 6 h 2597291"/>
              <a:gd name="connsiteX2" fmla="*/ 3686783 w 3686783"/>
              <a:gd name="connsiteY2" fmla="*/ 2577836 h 2597291"/>
              <a:gd name="connsiteX0" fmla="*/ 0 w 3686783"/>
              <a:gd name="connsiteY0" fmla="*/ 2597291 h 2597291"/>
              <a:gd name="connsiteX1" fmla="*/ 1789889 w 3686783"/>
              <a:gd name="connsiteY1" fmla="*/ 6 h 2597291"/>
              <a:gd name="connsiteX2" fmla="*/ 3686783 w 3686783"/>
              <a:gd name="connsiteY2" fmla="*/ 2577836 h 2597291"/>
              <a:gd name="connsiteX0" fmla="*/ 0 w 3686783"/>
              <a:gd name="connsiteY0" fmla="*/ 2597291 h 2597291"/>
              <a:gd name="connsiteX1" fmla="*/ 1789889 w 3686783"/>
              <a:gd name="connsiteY1" fmla="*/ 6 h 2597291"/>
              <a:gd name="connsiteX2" fmla="*/ 3686783 w 3686783"/>
              <a:gd name="connsiteY2" fmla="*/ 2577836 h 2597291"/>
              <a:gd name="connsiteX0" fmla="*/ 0 w 3686783"/>
              <a:gd name="connsiteY0" fmla="*/ 2597289 h 2597289"/>
              <a:gd name="connsiteX1" fmla="*/ 1789889 w 3686783"/>
              <a:gd name="connsiteY1" fmla="*/ 4 h 2597289"/>
              <a:gd name="connsiteX2" fmla="*/ 3686783 w 3686783"/>
              <a:gd name="connsiteY2" fmla="*/ 2577834 h 25972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686783" h="2597289">
                <a:moveTo>
                  <a:pt x="0" y="2597289"/>
                </a:moveTo>
                <a:cubicBezTo>
                  <a:pt x="864950" y="2598912"/>
                  <a:pt x="1175425" y="3246"/>
                  <a:pt x="1789889" y="4"/>
                </a:cubicBezTo>
                <a:cubicBezTo>
                  <a:pt x="2404353" y="-3238"/>
                  <a:pt x="2875334" y="2585944"/>
                  <a:pt x="3686783" y="2577834"/>
                </a:cubicBezTo>
              </a:path>
            </a:pathLst>
          </a:cu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4114269" y="4635623"/>
            <a:ext cx="41120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0                                   250                                 500</a:t>
            </a:r>
          </a:p>
          <a:p>
            <a:r>
              <a:rPr lang="en-US" sz="1600" dirty="0"/>
              <a:t>            Protein concentration (</a:t>
            </a:r>
            <a:r>
              <a:rPr lang="en-US" sz="1600" dirty="0" err="1"/>
              <a:t>nM</a:t>
            </a:r>
            <a:r>
              <a:rPr lang="en-US" sz="1600" dirty="0"/>
              <a:t>)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229303" y="4645364"/>
            <a:ext cx="3987327" cy="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V="1">
            <a:off x="4239030" y="2393004"/>
            <a:ext cx="0" cy="225236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 rot="16200000">
            <a:off x="2630045" y="3277864"/>
            <a:ext cx="235449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component amplitudes (arbitrary units)</a:t>
            </a:r>
          </a:p>
        </p:txBody>
      </p:sp>
    </p:spTree>
    <p:extLst>
      <p:ext uri="{BB962C8B-B14F-4D97-AF65-F5344CB8AC3E}">
        <p14:creationId xmlns:p14="http://schemas.microsoft.com/office/powerpoint/2010/main" val="2954357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Emory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nzi, Laura</dc:creator>
  <cp:lastModifiedBy>Finzi, Laura</cp:lastModifiedBy>
  <cp:revision>1</cp:revision>
  <dcterms:created xsi:type="dcterms:W3CDTF">2018-03-19T01:10:26Z</dcterms:created>
  <dcterms:modified xsi:type="dcterms:W3CDTF">2018-03-19T01:10:51Z</dcterms:modified>
</cp:coreProperties>
</file>